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8FFA7-7DD9-4DCD-B8B1-9242A85576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05EBA-8227-4A8C-A2F3-C222101F4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2F611-24D7-4475-93F8-9B73552AC5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4B853-D6AF-4087-BEBE-42FC53CF3E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B99C8-1B54-4532-B97B-07A80890D5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17193-DD40-4CBF-9A86-0AF884E750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9EBEF-C60E-42DE-B77C-E02E0674C0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0F8E1-74D9-4894-A783-265F3DF36D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B67CA-9E6E-407B-B332-AE1EB98202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D5F42-E3F8-4CAB-94E2-9CC3100C98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BE753-922B-4968-A988-00FB0F7193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AFA69-C530-4C1B-9A57-65D98C42C6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8F72FC-ADC4-4070-9A4E-3DB2311AAD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04920" y="1371600"/>
          <a:ext cx="8686800" cy="2546280"/>
        </p:xfrm>
        <a:graphic>
          <a:graphicData uri="http://schemas.openxmlformats.org/drawingml/2006/table">
            <a:tbl>
              <a:tblPr/>
              <a:tblGrid>
                <a:gridCol w="1541520"/>
                <a:gridCol w="1036440"/>
                <a:gridCol w="1035000"/>
                <a:gridCol w="1084320"/>
                <a:gridCol w="1165320"/>
                <a:gridCol w="941400"/>
                <a:gridCol w="941400"/>
                <a:gridCol w="941400"/>
              </a:tblGrid>
              <a:tr h="42264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Vill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pu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 rate 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%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49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Gunna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6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8.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45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Muns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8,0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.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45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anhy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,8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.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8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0,5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.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12"/>
          <p:cNvSpPr/>
          <p:nvPr/>
        </p:nvSpPr>
        <p:spPr>
          <a:xfrm>
            <a:off x="380880" y="914400"/>
            <a:ext cx="6477120" cy="41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3. Positive rate of fluorescent antibody responses of sera in Paju surveyed ar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4"/>
          <p:cNvSpPr/>
          <p:nvPr/>
        </p:nvSpPr>
        <p:spPr>
          <a:xfrm>
            <a:off x="990720" y="3962520"/>
            <a:ext cx="769608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 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* Significant between AAPI and positive rate of IFAT was analyzed by Two-way ANOVA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 =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0.4388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#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positive rate of IFAT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5306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1492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&amp;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AAPI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 =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0.5727, 2006;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1740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8:11Z</dcterms:created>
  <dc:creator>Lee</dc:creator>
  <dc:description/>
  <dc:language>en-US</dc:language>
  <cp:lastModifiedBy>Marcel Hommel</cp:lastModifiedBy>
  <dcterms:modified xsi:type="dcterms:W3CDTF">2012-07-22T10:28:41Z</dcterms:modified>
  <cp:revision>4</cp:revision>
  <dc:subject/>
  <dc:title>Slide 1</dc:title>
</cp:coreProperties>
</file>